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7242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7325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6381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5701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5610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39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7774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2039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4527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6182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4451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9696E-26F0-4E6B-8F39-742F5199B58B}" type="datetimeFigureOut">
              <a:rPr lang="ko-KR" altLang="en-US" smtClean="0"/>
              <a:pPr/>
              <a:t>2017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0763F-8470-40FE-8314-44FE186BD0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0409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611188" y="1557338"/>
          <a:ext cx="8104215" cy="3657615"/>
        </p:xfrm>
        <a:graphic>
          <a:graphicData uri="http://schemas.openxmlformats.org/drawingml/2006/table">
            <a:tbl>
              <a:tblPr>
                <a:effectLst>
                  <a:outerShdw blurRad="50800" dist="38100" dir="5400000" algn="t" rotWithShape="0">
                    <a:prstClr val="black">
                      <a:alpha val="40000"/>
                    </a:prstClr>
                  </a:outerShdw>
                </a:effectLst>
              </a:tblPr>
              <a:tblGrid>
                <a:gridCol w="1214487"/>
                <a:gridCol w="2385294"/>
                <a:gridCol w="960183"/>
                <a:gridCol w="2132615"/>
                <a:gridCol w="576110"/>
                <a:gridCol w="835526"/>
              </a:tblGrid>
              <a:tr h="270499">
                <a:tc rowSpan="2">
                  <a:txBody>
                    <a:bodyPr/>
                    <a:lstStyle/>
                    <a:p>
                      <a:pPr lvl="0"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Target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</a:p>
                  </a:txBody>
                  <a:tcPr marL="0" marR="7200" marT="7200" marB="5400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imer sequences</a:t>
                      </a:r>
                    </a:p>
                  </a:txBody>
                  <a:tcPr marL="0" marR="7200" marT="7200" marB="5400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ducts</a:t>
                      </a:r>
                      <a:b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</a:b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ize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0" marR="7200" marT="7200" marB="5400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87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orward</a:t>
                      </a:r>
                    </a:p>
                  </a:txBody>
                  <a:tcPr marL="0" marR="7200" marT="7200" marB="5400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m(℃)</a:t>
                      </a:r>
                    </a:p>
                  </a:txBody>
                  <a:tcPr marL="0" marR="7200" marT="7200" marB="5400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verse</a:t>
                      </a:r>
                    </a:p>
                  </a:txBody>
                  <a:tcPr marL="0" marR="7200" marT="7200" marB="5400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m(℃)</a:t>
                      </a:r>
                    </a:p>
                  </a:txBody>
                  <a:tcPr marL="0" marR="7200" marT="7200" marB="5400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lac1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accgcgttaccgaatgtgg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0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gtgctttcgcggagtaggg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07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4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lc38a4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cttgccgccacatccattgga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97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tcgggttcgatgctgacgttgt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85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4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19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aggcagagcaaaggcatcgcaa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67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tggggtcgaacccttccca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49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0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prm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tctcctcctggcgcaagg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85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tcacgttcatgccggcgt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98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3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la2g4f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agccaggcagcagcttcat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tggttcctcagcccacag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1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3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la2g4d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aaggctgggcaggtgaat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95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agccaggcagcagcttcat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97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0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sd17b7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ttgcatgcttgggcgtatt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acagcagcattccagcagca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99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5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mox1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ccaggggctgtgaactct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95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agtgggctagggaccccaaa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11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0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hac1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aggagtccgcatcccaga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5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gcaaagtccggcttccaca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0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38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r2</a:t>
                      </a: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aaccggatggattggctgt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7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tcgaagttagcaaaggccgc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94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1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0499"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lp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44000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tcgtgctcggtgtgctct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0 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ccctggtccacaggatccaa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0</a:t>
                      </a:r>
                    </a:p>
                  </a:txBody>
                  <a:tcPr marL="7776" marR="7776" marT="77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04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rnt1l</a:t>
                      </a:r>
                    </a:p>
                  </a:txBody>
                  <a:tcPr marL="144000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tttgcacatcctctgtggc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'-agctggagccagtgcaggag-3'</a:t>
                      </a:r>
                    </a:p>
                  </a:txBody>
                  <a:tcPr marL="21600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직사각형 4"/>
          <p:cNvSpPr/>
          <p:nvPr/>
        </p:nvSpPr>
        <p:spPr>
          <a:xfrm>
            <a:off x="611560" y="1135364"/>
            <a:ext cx="63367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smtClean="0">
                <a:latin typeface="Times New Roman" pitchFamily="18" charset="0"/>
                <a:cs typeface="Times New Roman" pitchFamily="18" charset="0"/>
              </a:rPr>
              <a:t>Table S1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.  A list of primers used for real-time PCR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607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71</Words>
  <Application>Microsoft Office PowerPoint</Application>
  <PresentationFormat>On-screen Show (4:3)</PresentationFormat>
  <Paragraphs>8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smin</dc:creator>
  <cp:lastModifiedBy>Balindan, Danica Joy</cp:lastModifiedBy>
  <cp:revision>8</cp:revision>
  <dcterms:created xsi:type="dcterms:W3CDTF">2015-10-30T08:23:08Z</dcterms:created>
  <dcterms:modified xsi:type="dcterms:W3CDTF">2017-03-22T19:52:56Z</dcterms:modified>
</cp:coreProperties>
</file>